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2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32" autoAdjust="0"/>
    <p:restoredTop sz="93738" autoAdjust="0"/>
  </p:normalViewPr>
  <p:slideViewPr>
    <p:cSldViewPr snapToGrid="0">
      <p:cViewPr varScale="1">
        <p:scale>
          <a:sx n="45" d="100"/>
          <a:sy n="45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443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4164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529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32239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2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2183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21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48702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5300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723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9269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5BAD7-CAFA-41DC-8FAB-86A39F9CEBF8}" type="datetimeFigureOut">
              <a:rPr lang="en-CA" smtClean="0"/>
              <a:t>2022-06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1BDDB-650A-4CBF-B5AB-3DDD9DF5BC7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441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TIF"/><Relationship Id="rId7" Type="http://schemas.openxmlformats.org/officeDocument/2006/relationships/image" Target="../media/image5.TIF"/><Relationship Id="rId12" Type="http://schemas.openxmlformats.org/officeDocument/2006/relationships/image" Target="../media/image10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9.TIF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TI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BF60D59-16D8-441F-8A28-2662E16793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248" y="1233715"/>
            <a:ext cx="3378836" cy="252682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42E5041-4852-4C0C-A7E9-2B4A1912D2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1296" y="4498091"/>
            <a:ext cx="3378836" cy="252682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D4C54EA-4712-4E48-A3B1-50AA9FB362A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248" y="4498090"/>
            <a:ext cx="3378836" cy="2526824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355350B2-C64E-4EFD-8FB1-BB821B24CD6D}"/>
              </a:ext>
            </a:extLst>
          </p:cNvPr>
          <p:cNvSpPr/>
          <p:nvPr/>
        </p:nvSpPr>
        <p:spPr>
          <a:xfrm>
            <a:off x="9848721" y="1357867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30ADCE0-47D8-4585-9F09-EA6F68AFC5B1}"/>
              </a:ext>
            </a:extLst>
          </p:cNvPr>
          <p:cNvSpPr/>
          <p:nvPr/>
        </p:nvSpPr>
        <p:spPr>
          <a:xfrm>
            <a:off x="6096000" y="4592540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-col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E4276DC-B094-44B9-9E7C-CB594315FA1A}"/>
              </a:ext>
            </a:extLst>
          </p:cNvPr>
          <p:cNvSpPr/>
          <p:nvPr/>
        </p:nvSpPr>
        <p:spPr>
          <a:xfrm>
            <a:off x="10027320" y="4592540"/>
            <a:ext cx="1197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14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BB43221-F40C-4596-A2ED-F9B165E70842}"/>
              </a:ext>
            </a:extLst>
          </p:cNvPr>
          <p:cNvSpPr txBox="1"/>
          <p:nvPr/>
        </p:nvSpPr>
        <p:spPr>
          <a:xfrm>
            <a:off x="2102051" y="843047"/>
            <a:ext cx="88537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CD45                                                   CD11b                                                     CD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C2DB89F-0315-4F13-B289-C880DADC1D60}"/>
              </a:ext>
            </a:extLst>
          </p:cNvPr>
          <p:cNvSpPr txBox="1"/>
          <p:nvPr/>
        </p:nvSpPr>
        <p:spPr>
          <a:xfrm>
            <a:off x="2130606" y="4090988"/>
            <a:ext cx="89932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CD19                                                    Pro-col                                                      K1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E13B4C1-5B1A-4182-A453-959D3A4A11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343" y="1233714"/>
            <a:ext cx="3378836" cy="252682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7A6E277-6866-46B8-BBBA-8A2A7BA68475}"/>
              </a:ext>
            </a:extLst>
          </p:cNvPr>
          <p:cNvSpPr/>
          <p:nvPr/>
        </p:nvSpPr>
        <p:spPr>
          <a:xfrm>
            <a:off x="2719214" y="1417824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E4B88F1-380F-442E-8E3A-9DDA19128E0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5753" y="1228857"/>
            <a:ext cx="3378836" cy="2526824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56B5F031-EB48-4E09-A2D8-BADF14009E25}"/>
              </a:ext>
            </a:extLst>
          </p:cNvPr>
          <p:cNvSpPr/>
          <p:nvPr/>
        </p:nvSpPr>
        <p:spPr>
          <a:xfrm>
            <a:off x="6198194" y="1328163"/>
            <a:ext cx="1488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055E7A-B540-4EC7-A1C2-41270D6952B6}"/>
              </a:ext>
            </a:extLst>
          </p:cNvPr>
          <p:cNvSpPr txBox="1"/>
          <p:nvPr/>
        </p:nvSpPr>
        <p:spPr>
          <a:xfrm>
            <a:off x="806657" y="11486095"/>
            <a:ext cx="10609943" cy="1444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: M-CSF-induced, splenocyte-derived adherent cells are CD11b-positive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use splenocytes were cultured in a medium containing 5 ng/ml of M-CSF for 3 days and then suspended cells were removed by three time washing with PBS. Culture medium containing 5 ng/ml of M-CSF was changed daily. After 10 day culture, cells were examined by immunofluorescent staining and FACS analysis.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fluorescent staining with indicated antibody. DAPI (blue) was used as a nuclear counterstain. Scale bars in all images were 50 µm. 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Adherent cells were harvested, fixed with fixation solution, stained with indicated antibody and analyzed by FACS.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708A80D-D7BE-491B-9100-4E0AD28D18DA}"/>
              </a:ext>
            </a:extLst>
          </p:cNvPr>
          <p:cNvCxnSpPr/>
          <p:nvPr/>
        </p:nvCxnSpPr>
        <p:spPr>
          <a:xfrm>
            <a:off x="3585029" y="3541485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D6337C8-598A-4287-B7FC-9ECA5CA6DD6C}"/>
              </a:ext>
            </a:extLst>
          </p:cNvPr>
          <p:cNvCxnSpPr/>
          <p:nvPr/>
        </p:nvCxnSpPr>
        <p:spPr>
          <a:xfrm>
            <a:off x="7102879" y="3563256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C418897D-C27E-406B-982E-40AD8E8B8949}"/>
              </a:ext>
            </a:extLst>
          </p:cNvPr>
          <p:cNvCxnSpPr/>
          <p:nvPr/>
        </p:nvCxnSpPr>
        <p:spPr>
          <a:xfrm>
            <a:off x="10586296" y="3570512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9CC0122B-504C-4EC4-995F-B9AB11B93D08}"/>
              </a:ext>
            </a:extLst>
          </p:cNvPr>
          <p:cNvCxnSpPr/>
          <p:nvPr/>
        </p:nvCxnSpPr>
        <p:spPr>
          <a:xfrm>
            <a:off x="7102879" y="6879771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7712294-D81D-425E-933F-E566AFEE243C}"/>
              </a:ext>
            </a:extLst>
          </p:cNvPr>
          <p:cNvCxnSpPr/>
          <p:nvPr/>
        </p:nvCxnSpPr>
        <p:spPr>
          <a:xfrm>
            <a:off x="10586296" y="6879771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3">
            <a:extLst>
              <a:ext uri="{FF2B5EF4-FFF2-40B4-BE49-F238E27FC236}">
                <a16:creationId xmlns:a16="http://schemas.microsoft.com/office/drawing/2014/main" id="{11FAE91A-5F25-4886-AD2C-4403633398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6214" y="8289783"/>
            <a:ext cx="2473348" cy="25470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3DF1D77-D938-4D57-A66E-A509ACE114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7796" y="8311379"/>
            <a:ext cx="2473347" cy="2547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ADA38AB-C0EE-4D8D-A373-53FB623B27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7590" y="8311379"/>
            <a:ext cx="2473347" cy="2547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">
            <a:extLst>
              <a:ext uri="{FF2B5EF4-FFF2-40B4-BE49-F238E27FC236}">
                <a16:creationId xmlns:a16="http://schemas.microsoft.com/office/drawing/2014/main" id="{A76A8296-EBAE-4947-B291-2D7AD9D385D4}"/>
              </a:ext>
            </a:extLst>
          </p:cNvPr>
          <p:cNvSpPr txBox="1"/>
          <p:nvPr/>
        </p:nvSpPr>
        <p:spPr>
          <a:xfrm>
            <a:off x="1753702" y="7931595"/>
            <a:ext cx="91790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.IgG control                              CD3e                                 CD11b                                 CD19                                         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D5623A3-3B58-4CBC-88F0-55E262B0B28B}"/>
              </a:ext>
            </a:extLst>
          </p:cNvPr>
          <p:cNvSpPr txBox="1"/>
          <p:nvPr/>
        </p:nvSpPr>
        <p:spPr>
          <a:xfrm>
            <a:off x="512433" y="539186"/>
            <a:ext cx="6878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3446D3A-714E-4AA1-94E9-1989FE8C5D5F}"/>
              </a:ext>
            </a:extLst>
          </p:cNvPr>
          <p:cNvSpPr txBox="1"/>
          <p:nvPr/>
        </p:nvSpPr>
        <p:spPr>
          <a:xfrm>
            <a:off x="461601" y="7346317"/>
            <a:ext cx="837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70ABC71-AD61-45F0-BA01-1C99FE77901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299" y="4496293"/>
            <a:ext cx="3378836" cy="2526824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F66C0509-01AB-4D7D-B4E4-46C870786FE0}"/>
              </a:ext>
            </a:extLst>
          </p:cNvPr>
          <p:cNvSpPr/>
          <p:nvPr/>
        </p:nvSpPr>
        <p:spPr>
          <a:xfrm>
            <a:off x="2859146" y="4609098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CA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ED7D64F-92E2-421D-ACEB-A10EF4008993}"/>
              </a:ext>
            </a:extLst>
          </p:cNvPr>
          <p:cNvCxnSpPr/>
          <p:nvPr/>
        </p:nvCxnSpPr>
        <p:spPr>
          <a:xfrm>
            <a:off x="3609562" y="6879771"/>
            <a:ext cx="51148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Picture 4">
            <a:extLst>
              <a:ext uri="{FF2B5EF4-FFF2-40B4-BE49-F238E27FC236}">
                <a16:creationId xmlns:a16="http://schemas.microsoft.com/office/drawing/2014/main" id="{7A172E0B-44FE-4B36-AAA2-CEE2304D94F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1"/>
          <a:stretch/>
        </p:blipFill>
        <p:spPr bwMode="auto">
          <a:xfrm>
            <a:off x="6083153" y="8313111"/>
            <a:ext cx="2432427" cy="25452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1587557-F400-4042-AE85-52C462C1711A}"/>
              </a:ext>
            </a:extLst>
          </p:cNvPr>
          <p:cNvSpPr txBox="1"/>
          <p:nvPr/>
        </p:nvSpPr>
        <p:spPr>
          <a:xfrm>
            <a:off x="2428096" y="8765300"/>
            <a:ext cx="6896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0.3%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4E0EA38-4951-45CC-9F83-8FD449E7C81C}"/>
              </a:ext>
            </a:extLst>
          </p:cNvPr>
          <p:cNvSpPr/>
          <p:nvPr/>
        </p:nvSpPr>
        <p:spPr>
          <a:xfrm>
            <a:off x="4784469" y="8765300"/>
            <a:ext cx="6527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1.9%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E3C1351-F396-468D-A12D-E310125F44AD}"/>
              </a:ext>
            </a:extLst>
          </p:cNvPr>
          <p:cNvSpPr/>
          <p:nvPr/>
        </p:nvSpPr>
        <p:spPr>
          <a:xfrm>
            <a:off x="6847807" y="8797671"/>
            <a:ext cx="76655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94.6%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48A115B-DADD-4D7D-80F1-07BB3156A4E8}"/>
              </a:ext>
            </a:extLst>
          </p:cNvPr>
          <p:cNvSpPr/>
          <p:nvPr/>
        </p:nvSpPr>
        <p:spPr>
          <a:xfrm>
            <a:off x="9820508" y="8765300"/>
            <a:ext cx="6527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4.5%</a:t>
            </a:r>
          </a:p>
        </p:txBody>
      </p:sp>
    </p:spTree>
    <p:extLst>
      <p:ext uri="{BB962C8B-B14F-4D97-AF65-F5344CB8AC3E}">
        <p14:creationId xmlns:p14="http://schemas.microsoft.com/office/powerpoint/2010/main" val="54931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</TotalTime>
  <Words>160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nyuan</dc:creator>
  <cp:lastModifiedBy>chn off31</cp:lastModifiedBy>
  <cp:revision>65</cp:revision>
  <dcterms:created xsi:type="dcterms:W3CDTF">2018-08-16T19:41:08Z</dcterms:created>
  <dcterms:modified xsi:type="dcterms:W3CDTF">2022-06-15T08:49:12Z</dcterms:modified>
</cp:coreProperties>
</file>